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8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96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171809-84EB-728D-6053-3FA42E4937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22E8F46-367E-25C2-9CD1-00B1554C42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1AD684-4078-EDDA-0F9B-6994637F7C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C886FC-CD3C-41E8-D7BF-CF4142EBD7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4C5949-5EAD-0DB3-DD1E-5478E7D37D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927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5AABC1-CD5E-5EFF-89D4-D6A325D3FA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F2041E-2EFA-6D80-3C3A-A4B7E97BB1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DDB4F4-0251-504B-844F-7CE3F692E4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D5FEC3-CB81-B83D-F168-BFAE006E7D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A68F54-080F-8B7E-772B-ED00526573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4138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3C94210-6013-D5CD-DAC2-5098BCD6A8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DD018F-40B1-F496-8F28-F9917E9B64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F4ECFF-4B4E-6B8D-6694-4C054DA2E5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788D37-7CB7-7DF4-8302-6B344BE8F2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D12FAA-824C-BF39-6106-EF191B5300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0810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BBA225-1AA9-4B2E-698A-07F98457B9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560AC9-F28E-0B9B-ABE1-3DEF3BB7ECD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A9E263-F052-7FDA-CF76-08E3EBAE9C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434D50-6756-5A7D-3BC7-284AD18005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11B3E6-64C5-021B-5971-3E3EABCFF8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924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DA577B-F353-3395-C642-23A37E58FE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EA07F5-EAE2-C8D3-A971-43EF3E842D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22B12A-DC6D-1FD9-B2D2-862BD2EC5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CD478E-AB42-5C55-06BC-6A3FCC22B8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FB234F-EE17-E117-0660-AD3A984268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1653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F54979-A720-F51B-11A0-0956DEADE1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E2E23F-4040-DE56-C8B2-406952840C5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B5F3886-A9C3-942A-F942-48F28ABE2B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3AA20B-3582-F132-1682-EFCE77F95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B3E350-F99D-3C60-ACB6-5A5D50DD1A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2A48B3-E627-52AC-C493-E9C2465A2C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2406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188257-498A-A061-23D8-7AB7DEF930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8676AC-D607-CB84-1397-E2753F87C3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20CC96-059D-7937-0BDC-E10884A73F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8AB2BD1-941B-A974-C453-1A9B0A7A125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E964FB9-7E82-166B-8E8F-92B34538A85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4B5B1E9-25BC-A446-B195-3CF9944400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6D8308F-006C-5C1A-D2D7-B7B9545C52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89122EC-0F98-9842-AFCD-A1D61F5982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25754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2EDE35-960C-5D70-0975-D838E76595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4F01722-2857-98DF-8EC6-E1C6C171CE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CF152B0-298B-4628-75E0-BE0FFF4191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FC6B53F-37F1-50B0-41E9-4CE68CB9F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863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03A9F24-CD29-9F21-C118-2E9838586B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CB858D9-2463-D8BC-D20B-DBA0340D3F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90FA327-EC93-C4AC-AD50-994B9E0A0C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428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FCB03F-9847-C305-79C1-1002A472E4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B7C495-60EC-1D44-A86D-63F016809F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784E4C-DE5B-1E82-7EAC-B5A8BC1040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859101-E9AE-1526-144E-60EF9E7E8E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12E089-DB36-5F97-9D05-91B1EBB223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E68142-85B6-F708-E1F5-482AFDF2F5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8423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AE85FD-0477-349D-C459-8C2B98435F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3F4FC84-ECF1-1506-AC52-FD47F2EA65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D58F79-D79B-205A-F000-98CCE3E982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ABFFA4-0C26-DEB3-C56B-EEC956A190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661803-1EE9-B997-2AEA-9E814345E4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9D3228-F668-D74B-4C5F-156CFDD551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2163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6D8A09-E747-828F-A10B-F52707DC89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F18A04-B462-A53E-3640-3628B2E8ED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682162-C704-7497-9487-92C16817281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2369F4-0CD6-C663-BBF0-7B94690E7D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7AA8E1-1188-7B45-C931-2918D0AF69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351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44131C1F-2C77-4B4F-A954-5B234A6A811F}"/>
              </a:ext>
            </a:extLst>
          </p:cNvPr>
          <p:cNvGraphicFramePr>
            <a:graphicFrameLocks noGrp="1"/>
          </p:cNvGraphicFramePr>
          <p:nvPr/>
        </p:nvGraphicFramePr>
        <p:xfrm>
          <a:off x="4272436" y="2011586"/>
          <a:ext cx="3242789" cy="3636741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682962">
                  <a:extLst>
                    <a:ext uri="{9D8B030D-6E8A-4147-A177-3AD203B41FA5}">
                      <a16:colId xmlns:a16="http://schemas.microsoft.com/office/drawing/2014/main" val="2867660108"/>
                    </a:ext>
                  </a:extLst>
                </a:gridCol>
                <a:gridCol w="1059402">
                  <a:extLst>
                    <a:ext uri="{9D8B030D-6E8A-4147-A177-3AD203B41FA5}">
                      <a16:colId xmlns:a16="http://schemas.microsoft.com/office/drawing/2014/main" val="3173880691"/>
                    </a:ext>
                  </a:extLst>
                </a:gridCol>
                <a:gridCol w="1500425">
                  <a:extLst>
                    <a:ext uri="{9D8B030D-6E8A-4147-A177-3AD203B41FA5}">
                      <a16:colId xmlns:a16="http://schemas.microsoft.com/office/drawing/2014/main" val="2657427830"/>
                    </a:ext>
                  </a:extLst>
                </a:gridCol>
              </a:tblGrid>
              <a:tr h="265801"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/>
                          <a:cs typeface="Arial" panose="020B0604020202020204"/>
                        </a:rPr>
                        <a:t>Ran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/>
                        <a:t>Upregulated</a:t>
                      </a:r>
                      <a:endParaRPr lang="en-US" sz="1000" b="1" dirty="0">
                        <a:latin typeface="Arial" panose="020B0604020202020204"/>
                        <a:cs typeface="Arial" panose="020B0604020202020204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/>
                        <a:t>Downregulated </a:t>
                      </a:r>
                      <a:endParaRPr lang="en-US" sz="1000" b="1" dirty="0">
                        <a:latin typeface="Arial" panose="020B0604020202020204"/>
                        <a:cs typeface="Arial" panose="020B0604020202020204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19083856"/>
                  </a:ext>
                </a:extLst>
              </a:tr>
              <a:tr h="1673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XIS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RT4 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54185332"/>
                  </a:ext>
                </a:extLst>
              </a:tr>
              <a:tr h="167301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</a:t>
                      </a:r>
                      <a:endParaRPr lang="en-US" sz="900" b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RP6-24A23.7</a:t>
                      </a:r>
                      <a:endParaRPr lang="en-US" sz="900" b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PRR1B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18989153"/>
                  </a:ext>
                </a:extLst>
              </a:tr>
              <a:tr h="1673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RS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RT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46039015"/>
                  </a:ext>
                </a:extLst>
              </a:tr>
              <a:tr h="1673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VI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PRR1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50989267"/>
                  </a:ext>
                </a:extLst>
              </a:tr>
              <a:tr h="19222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PC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NLIPRP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73180662"/>
                  </a:ext>
                </a:extLst>
              </a:tr>
              <a:tr h="167301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</a:t>
                      </a:r>
                      <a:endParaRPr lang="en-US" sz="900" b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ALCB</a:t>
                      </a:r>
                      <a:endParaRPr lang="en-US" sz="900" b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LDH3B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84112995"/>
                  </a:ext>
                </a:extLst>
              </a:tr>
              <a:tr h="167301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en-US" sz="900" b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LT4</a:t>
                      </a:r>
                      <a:endParaRPr lang="en-US" sz="900" b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Y6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02431219"/>
                  </a:ext>
                </a:extLst>
              </a:tr>
              <a:tr h="167301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900" b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ONRF2</a:t>
                      </a:r>
                      <a:endParaRPr lang="en-US" sz="900" b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ZBED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69281174"/>
                  </a:ext>
                </a:extLst>
              </a:tr>
              <a:tr h="1673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LC7A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EACAM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35128065"/>
                  </a:ext>
                </a:extLst>
              </a:tr>
              <a:tr h="1673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ADM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EACAM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2557285"/>
                  </a:ext>
                </a:extLst>
              </a:tr>
              <a:tr h="1673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/>
                        </a:rPr>
                        <a:t>1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MOC1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FI44L</a:t>
                      </a: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597614414"/>
                  </a:ext>
                </a:extLst>
              </a:tr>
              <a:tr h="1673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/>
                        </a:rPr>
                        <a:t>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PYSL5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RT23</a:t>
                      </a: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2468365700"/>
                  </a:ext>
                </a:extLst>
              </a:tr>
              <a:tr h="1673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/>
                        </a:rPr>
                        <a:t>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ZNF711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TB-113P19.4</a:t>
                      </a: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4009348610"/>
                  </a:ext>
                </a:extLst>
              </a:tr>
              <a:tr h="1673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/>
                        </a:rPr>
                        <a:t>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RP3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KP1</a:t>
                      </a: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897355615"/>
                  </a:ext>
                </a:extLst>
              </a:tr>
              <a:tr h="1673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/>
                        </a:rPr>
                        <a:t>1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LEC12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MP13</a:t>
                      </a: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1807387342"/>
                  </a:ext>
                </a:extLst>
              </a:tr>
              <a:tr h="1673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/>
                        </a:rPr>
                        <a:t>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SI1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ALL</a:t>
                      </a: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4086454873"/>
                  </a:ext>
                </a:extLst>
              </a:tr>
              <a:tr h="1673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/>
                        </a:rPr>
                        <a:t>1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PR27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VSNL1</a:t>
                      </a: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4131106556"/>
                  </a:ext>
                </a:extLst>
              </a:tr>
              <a:tr h="1673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/>
                        </a:rPr>
                        <a:t>1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DC2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OXN1</a:t>
                      </a: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94077279"/>
                  </a:ext>
                </a:extLst>
              </a:tr>
              <a:tr h="1673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/>
                        </a:rPr>
                        <a:t>1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ID1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YPD2</a:t>
                      </a: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876045476"/>
                  </a:ext>
                </a:extLst>
              </a:tr>
              <a:tr h="1673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/>
                        </a:rPr>
                        <a:t>2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PB41L3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PRR2D</a:t>
                      </a: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2820751846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DC8AD7DC-78EB-4FFC-C242-86B6AD41030D}"/>
              </a:ext>
            </a:extLst>
          </p:cNvPr>
          <p:cNvSpPr txBox="1"/>
          <p:nvPr/>
        </p:nvSpPr>
        <p:spPr>
          <a:xfrm>
            <a:off x="4490526" y="1329356"/>
            <a:ext cx="2326919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Supplementary Table 3: Top 20 </a:t>
            </a:r>
          </a:p>
          <a:p>
            <a:pPr algn="ctr"/>
            <a:r>
              <a:rPr lang="en-US" sz="1200" b="1" dirty="0"/>
              <a:t>Upregulated/Downregulated </a:t>
            </a:r>
          </a:p>
          <a:p>
            <a:pPr algn="ctr"/>
            <a:r>
              <a:rPr lang="en-US" sz="1200" b="1" dirty="0"/>
              <a:t>DEGs in C-Term vs Control</a:t>
            </a:r>
          </a:p>
          <a:p>
            <a:pPr algn="ctr"/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2867260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7</Words>
  <Application>Microsoft Office PowerPoint</Application>
  <PresentationFormat>Widescreen</PresentationFormat>
  <Paragraphs>6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urnett, Andrean L</dc:creator>
  <cp:lastModifiedBy>Burnett, Andrean L</cp:lastModifiedBy>
  <cp:revision>2</cp:revision>
  <dcterms:created xsi:type="dcterms:W3CDTF">2026-02-26T15:58:59Z</dcterms:created>
  <dcterms:modified xsi:type="dcterms:W3CDTF">2026-02-26T15:59:52Z</dcterms:modified>
</cp:coreProperties>
</file>